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47"/>
  </p:normalViewPr>
  <p:slideViewPr>
    <p:cSldViewPr snapToGrid="0" snapToObjects="1">
      <p:cViewPr varScale="1">
        <p:scale>
          <a:sx n="133" d="100"/>
          <a:sy n="133" d="100"/>
        </p:scale>
        <p:origin x="216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3B8DD5-1C66-8A41-9911-4AA91A1FD739}" type="datetimeFigureOut">
              <a:rPr lang="en-US" smtClean="0"/>
              <a:t>5/3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1EDF74-090F-7848-9F56-A1429372AA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0441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4F3BED-E3BC-2D4D-87FA-BA94EDA9F98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5197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955406-9BD2-2F44-9719-BA47173A7A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13830F-5407-0048-8E4A-FCDED0FECA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4EBE58-C526-6B48-BD8F-1F646EEBC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F1989F-DBD6-E646-9A80-DBB886113D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3FFC88-65F6-1A42-A029-E7E317E57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641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2FF120-3BB2-D942-8D31-7F8067908C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AF3E55-CF04-F647-8465-3672F88E2F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2DB7A9-EB5D-6947-B89A-8F772BD2F0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50FEDA-BBD8-F647-849B-7C9122FB2E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D5A19C-A005-F84E-AF2B-BA3DA0C1A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533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42DAAC5-C971-B844-B62E-5039374BC2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251E9B-B42A-FA42-A67D-1AF6836AEC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2246C8-45D5-BF40-ADDB-62E2DD382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C81622-9BC2-CD4B-A23B-23BC96513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6CB7D6-8890-A347-ABCA-BC1E2F0FE2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4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B7A571-4BAD-5844-9875-236DCDBB21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604E29-434D-054A-92A5-0A27F0A210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BA056C-1128-EC4F-9903-B38E21661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57F3A4-5658-D841-9A46-EB6B343D3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A54AD9-F2A3-B949-AA13-A9880F197E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469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1B88B1-E646-6D4A-8681-D71B36BC70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9EB869-51E9-A44F-9832-C21C23DC4B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264DDF-2224-AD4E-B57B-CED7A3E508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7C32F6-D578-B14E-A720-3CEE640413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F7A360-AC68-7F41-9340-8422B6D3A2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494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471346-6A85-A54B-8E91-CDF31D9839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069D61-597B-D748-8F26-2FDA2A3D8D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9B0681-977A-344E-B706-AA7E963D98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D14A31-7406-0E48-896B-7B4CBB680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B43B79-6786-7A49-B28B-514E27403D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03E007-9720-3C47-BE88-3CCE1C281D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8764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5F080A-C4B1-6144-860D-507A704808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FEEE26-8A9B-8D43-8481-23D0BAC0E1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E97174-12DD-2A49-88A4-79572ACD6E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564D79-A22C-6F4B-BF2A-AA9D9D92CD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C2EAF6E-C231-AA46-8168-41FEECCA26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3877DE-FA98-F244-987F-7ECC183F5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A7EA34A-5D8A-4B45-AE2E-7FC888EA5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BA5AFF7-CC0B-454A-BCB4-95F297386A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728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3B6F98-2826-964C-AE09-237A5C799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685B53-C224-0540-8D82-1752FC6B9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D1FC06-AF7F-FB46-9233-A7DB4B31A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766F60-6695-1C48-A29E-06B74A323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572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9C4435-05A4-D04C-8232-772DD6FD3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7B81FC9-BED7-4F47-8145-ABF5CFE5F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1DB4D9-2E23-824B-AB33-E9B052174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566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81B63F-0915-CB4D-8E0B-DB723A0C1C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DC5936-E1D1-DB4C-9004-41884603EF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A2C12A-FCB4-694D-B33A-E8FF13AF88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203CE7-21B4-CC48-82D1-F8AA48402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AFBCCF-226A-364E-AB86-FDC8E7D607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4542E9-1071-9543-9AE6-A65B560DD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3405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124A11-C618-C54D-970C-70EC2EB8AD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90E175-0E01-A845-B92E-7B060A847A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011DD3-BFB2-AF43-85E4-EC56D6D58B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D17AC5-1702-9643-B9B3-27E2A24BA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B57E87-F697-7F40-A871-7EB6535B2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1773A6-5120-AE4C-82C9-E17DBBFA0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437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94F9DF-2363-CA49-AEA6-232709069D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0860AA-AC2A-0F45-BEFF-592F177917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94CC7C-D535-E841-A019-BA343C1615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399C1C-28E8-E846-956F-C13721CF6212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E3DB0E-6143-3F46-99A1-D0314393AA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3842FE-C006-3242-BCA2-D186AD1B2C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4B77B-4CE5-D543-AD56-4F7D1A6B5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471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10" Type="http://schemas.openxmlformats.org/officeDocument/2006/relationships/image" Target="../media/image8.jpg"/><Relationship Id="rId4" Type="http://schemas.openxmlformats.org/officeDocument/2006/relationships/image" Target="../media/image2.jpg"/><Relationship Id="rId9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6643321" y="744765"/>
            <a:ext cx="51800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P4 CONTROLS</a:t>
            </a:r>
          </a:p>
          <a:p>
            <a:pPr algn="ctr"/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D926DB56-42BE-9846-BD62-C0C4708F44E6}"/>
              </a:ext>
            </a:extLst>
          </p:cNvPr>
          <p:cNvGrpSpPr/>
          <p:nvPr/>
        </p:nvGrpSpPr>
        <p:grpSpPr>
          <a:xfrm>
            <a:off x="-85353" y="0"/>
            <a:ext cx="6148011" cy="6405605"/>
            <a:chOff x="1466577" y="205426"/>
            <a:chExt cx="6148011" cy="6405605"/>
          </a:xfrm>
        </p:grpSpPr>
        <p:grpSp>
          <p:nvGrpSpPr>
            <p:cNvPr id="24" name="Group 23"/>
            <p:cNvGrpSpPr/>
            <p:nvPr/>
          </p:nvGrpSpPr>
          <p:grpSpPr>
            <a:xfrm>
              <a:off x="1466577" y="205426"/>
              <a:ext cx="4258876" cy="2120995"/>
              <a:chOff x="3340777" y="578697"/>
              <a:chExt cx="4258876" cy="2120995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5212857" y="578697"/>
                <a:ext cx="238679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° </a:t>
                </a:r>
                <a:r>
                  <a:rPr lang="el-GR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340777" y="578697"/>
                <a:ext cx="238679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e-Bleed</a:t>
                </a:r>
              </a:p>
            </p:txBody>
          </p:sp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91855" y="870892"/>
                <a:ext cx="1828800" cy="1828800"/>
              </a:xfrm>
              <a:prstGeom prst="rect">
                <a:avLst/>
              </a:prstGeom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19775" y="870892"/>
                <a:ext cx="1828800" cy="1828800"/>
              </a:xfrm>
              <a:prstGeom prst="rect">
                <a:avLst/>
              </a:prstGeom>
            </p:spPr>
          </p:pic>
        </p:grpSp>
        <p:grpSp>
          <p:nvGrpSpPr>
            <p:cNvPr id="39" name="Group 38"/>
            <p:cNvGrpSpPr/>
            <p:nvPr/>
          </p:nvGrpSpPr>
          <p:grpSpPr>
            <a:xfrm>
              <a:off x="1751428" y="2258792"/>
              <a:ext cx="5613632" cy="2163702"/>
              <a:chOff x="1594772" y="2742686"/>
              <a:chExt cx="5613632" cy="2163702"/>
            </a:xfrm>
          </p:grpSpPr>
          <p:grpSp>
            <p:nvGrpSpPr>
              <p:cNvPr id="34" name="Group 33"/>
              <p:cNvGrpSpPr/>
              <p:nvPr/>
            </p:nvGrpSpPr>
            <p:grpSpPr>
              <a:xfrm>
                <a:off x="3194087" y="2752892"/>
                <a:ext cx="2386796" cy="2143291"/>
                <a:chOff x="1460683" y="2658914"/>
                <a:chExt cx="2386796" cy="2143291"/>
              </a:xfrm>
            </p:grpSpPr>
            <p:sp>
              <p:nvSpPr>
                <p:cNvPr id="9" name="TextBox 8"/>
                <p:cNvSpPr txBox="1"/>
                <p:nvPr/>
              </p:nvSpPr>
              <p:spPr>
                <a:xfrm>
                  <a:off x="1460683" y="2658914"/>
                  <a:ext cx="238679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etB</a:t>
                  </a:r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+ </a:t>
                  </a:r>
                  <a:r>
                    <a:rPr lang="en-US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etB</a:t>
                  </a:r>
                  <a:endParaRPr 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7" name="Picture 16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739681" y="2973405"/>
                  <a:ext cx="1828800" cy="1828800"/>
                </a:xfrm>
                <a:prstGeom prst="rect">
                  <a:avLst/>
                </a:prstGeom>
              </p:spPr>
            </p:pic>
          </p:grpSp>
          <p:grpSp>
            <p:nvGrpSpPr>
              <p:cNvPr id="35" name="Group 34"/>
              <p:cNvGrpSpPr/>
              <p:nvPr/>
            </p:nvGrpSpPr>
            <p:grpSpPr>
              <a:xfrm>
                <a:off x="5379604" y="2742686"/>
                <a:ext cx="1828800" cy="2163702"/>
                <a:chOff x="3646200" y="2658914"/>
                <a:chExt cx="1828800" cy="2163702"/>
              </a:xfrm>
            </p:grpSpPr>
            <p:sp>
              <p:nvSpPr>
                <p:cNvPr id="14" name="TextBox 13"/>
                <p:cNvSpPr txBox="1"/>
                <p:nvPr/>
              </p:nvSpPr>
              <p:spPr>
                <a:xfrm>
                  <a:off x="3753449" y="2658914"/>
                  <a:ext cx="161430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etB</a:t>
                  </a:r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+ FBA</a:t>
                  </a:r>
                </a:p>
              </p:txBody>
            </p:sp>
            <p:pic>
              <p:nvPicPr>
                <p:cNvPr id="22" name="Picture 21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46200" y="2993816"/>
                  <a:ext cx="1828800" cy="1828800"/>
                </a:xfrm>
                <a:prstGeom prst="rect">
                  <a:avLst/>
                </a:prstGeom>
              </p:spPr>
            </p:pic>
          </p:grpSp>
          <p:grpSp>
            <p:nvGrpSpPr>
              <p:cNvPr id="33" name="Group 32"/>
              <p:cNvGrpSpPr/>
              <p:nvPr/>
            </p:nvGrpSpPr>
            <p:grpSpPr>
              <a:xfrm>
                <a:off x="1594772" y="2742686"/>
                <a:ext cx="1828800" cy="2163702"/>
                <a:chOff x="-138632" y="2658914"/>
                <a:chExt cx="1828800" cy="2163702"/>
              </a:xfrm>
            </p:grpSpPr>
            <p:pic>
              <p:nvPicPr>
                <p:cNvPr id="27" name="Picture 26"/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138632" y="2993816"/>
                  <a:ext cx="1828800" cy="1828800"/>
                </a:xfrm>
                <a:prstGeom prst="rect">
                  <a:avLst/>
                </a:prstGeom>
              </p:spPr>
            </p:pic>
            <p:sp>
              <p:nvSpPr>
                <p:cNvPr id="31" name="TextBox 30"/>
                <p:cNvSpPr txBox="1"/>
                <p:nvPr/>
              </p:nvSpPr>
              <p:spPr>
                <a:xfrm>
                  <a:off x="107113" y="2658914"/>
                  <a:ext cx="133731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ɑ-</a:t>
                  </a:r>
                  <a:r>
                    <a:rPr lang="en-US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etB</a:t>
                  </a:r>
                  <a:endParaRPr 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40" name="Group 39"/>
            <p:cNvGrpSpPr/>
            <p:nvPr/>
          </p:nvGrpSpPr>
          <p:grpSpPr>
            <a:xfrm>
              <a:off x="1747172" y="4458869"/>
              <a:ext cx="5867416" cy="2152162"/>
              <a:chOff x="1624242" y="4848227"/>
              <a:chExt cx="5867416" cy="2152162"/>
            </a:xfrm>
          </p:grpSpPr>
          <p:grpSp>
            <p:nvGrpSpPr>
              <p:cNvPr id="37" name="Group 36"/>
              <p:cNvGrpSpPr/>
              <p:nvPr/>
            </p:nvGrpSpPr>
            <p:grpSpPr>
              <a:xfrm>
                <a:off x="3473085" y="4848227"/>
                <a:ext cx="1828800" cy="2152162"/>
                <a:chOff x="1747316" y="4754249"/>
                <a:chExt cx="1828800" cy="2152162"/>
              </a:xfrm>
            </p:grpSpPr>
            <p:sp>
              <p:nvSpPr>
                <p:cNvPr id="29" name="TextBox 28"/>
                <p:cNvSpPr txBox="1"/>
                <p:nvPr/>
              </p:nvSpPr>
              <p:spPr>
                <a:xfrm>
                  <a:off x="1866140" y="4754249"/>
                  <a:ext cx="162479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FBA + FBA</a:t>
                  </a:r>
                </a:p>
              </p:txBody>
            </p:sp>
            <p:pic>
              <p:nvPicPr>
                <p:cNvPr id="16" name="Picture 15"/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747316" y="5077611"/>
                  <a:ext cx="1828800" cy="1828800"/>
                </a:xfrm>
                <a:prstGeom prst="rect">
                  <a:avLst/>
                </a:prstGeom>
              </p:spPr>
            </p:pic>
          </p:grpSp>
          <p:grpSp>
            <p:nvGrpSpPr>
              <p:cNvPr id="38" name="Group 37"/>
              <p:cNvGrpSpPr/>
              <p:nvPr/>
            </p:nvGrpSpPr>
            <p:grpSpPr>
              <a:xfrm>
                <a:off x="5104862" y="4869492"/>
                <a:ext cx="2386796" cy="2130897"/>
                <a:chOff x="3379093" y="4775514"/>
                <a:chExt cx="2386796" cy="2130897"/>
              </a:xfrm>
            </p:grpSpPr>
            <p:sp>
              <p:nvSpPr>
                <p:cNvPr id="13" name="TextBox 12"/>
                <p:cNvSpPr txBox="1"/>
                <p:nvPr/>
              </p:nvSpPr>
              <p:spPr>
                <a:xfrm>
                  <a:off x="3379093" y="4775514"/>
                  <a:ext cx="238679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FBA + </a:t>
                  </a:r>
                  <a:r>
                    <a:rPr lang="en-US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etB</a:t>
                  </a:r>
                  <a:endParaRPr 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1" name="Picture 20"/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63055" y="5077611"/>
                  <a:ext cx="1828800" cy="1828800"/>
                </a:xfrm>
                <a:prstGeom prst="rect">
                  <a:avLst/>
                </a:prstGeom>
              </p:spPr>
            </p:pic>
          </p:grpSp>
          <p:grpSp>
            <p:nvGrpSpPr>
              <p:cNvPr id="36" name="Group 35"/>
              <p:cNvGrpSpPr/>
              <p:nvPr/>
            </p:nvGrpSpPr>
            <p:grpSpPr>
              <a:xfrm>
                <a:off x="1624242" y="4848227"/>
                <a:ext cx="1828800" cy="2152162"/>
                <a:chOff x="-101527" y="4754249"/>
                <a:chExt cx="1828800" cy="2152162"/>
              </a:xfrm>
            </p:grpSpPr>
            <p:pic>
              <p:nvPicPr>
                <p:cNvPr id="28" name="Picture 27"/>
                <p:cNvPicPr>
                  <a:picLocks noChangeAspect="1"/>
                </p:cNvPicPr>
                <p:nvPr/>
              </p:nvPicPr>
              <p:blipFill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101527" y="5077611"/>
                  <a:ext cx="1828800" cy="1828800"/>
                </a:xfrm>
                <a:prstGeom prst="rect">
                  <a:avLst/>
                </a:prstGeom>
              </p:spPr>
            </p:pic>
            <p:sp>
              <p:nvSpPr>
                <p:cNvPr id="32" name="TextBox 31"/>
                <p:cNvSpPr txBox="1"/>
                <p:nvPr/>
              </p:nvSpPr>
              <p:spPr>
                <a:xfrm>
                  <a:off x="144218" y="4754249"/>
                  <a:ext cx="133731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ɑ-FBA</a:t>
                  </a:r>
                </a:p>
              </p:txBody>
            </p:sp>
          </p:grpSp>
        </p:grpSp>
      </p:grpSp>
      <p:grpSp>
        <p:nvGrpSpPr>
          <p:cNvPr id="59" name="Group 58"/>
          <p:cNvGrpSpPr/>
          <p:nvPr/>
        </p:nvGrpSpPr>
        <p:grpSpPr>
          <a:xfrm>
            <a:off x="4472862" y="6421560"/>
            <a:ext cx="1453340" cy="314066"/>
            <a:chOff x="5871831" y="6533253"/>
            <a:chExt cx="1453340" cy="314066"/>
          </a:xfrm>
        </p:grpSpPr>
        <p:grpSp>
          <p:nvGrpSpPr>
            <p:cNvPr id="57" name="Group 56"/>
            <p:cNvGrpSpPr/>
            <p:nvPr/>
          </p:nvGrpSpPr>
          <p:grpSpPr>
            <a:xfrm>
              <a:off x="5930927" y="6778342"/>
              <a:ext cx="1251319" cy="68977"/>
              <a:chOff x="5930927" y="6778342"/>
              <a:chExt cx="1251319" cy="68977"/>
            </a:xfrm>
          </p:grpSpPr>
          <p:cxnSp>
            <p:nvCxnSpPr>
              <p:cNvPr id="6" name="Straight Connector 5"/>
              <p:cNvCxnSpPr/>
              <p:nvPr/>
            </p:nvCxnSpPr>
            <p:spPr>
              <a:xfrm>
                <a:off x="5930927" y="6842162"/>
                <a:ext cx="1251319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 flipV="1">
                <a:off x="5937076" y="6778342"/>
                <a:ext cx="0" cy="638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 flipV="1">
                <a:off x="6183786" y="6778342"/>
                <a:ext cx="0" cy="638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 flipV="1">
                <a:off x="6431863" y="6778342"/>
                <a:ext cx="0" cy="638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 flipV="1">
                <a:off x="6688142" y="6778342"/>
                <a:ext cx="0" cy="638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 flipV="1">
                <a:off x="6936219" y="6778342"/>
                <a:ext cx="0" cy="638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 flipV="1">
                <a:off x="7178809" y="6783499"/>
                <a:ext cx="0" cy="638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" name="TextBox 48"/>
            <p:cNvSpPr txBox="1"/>
            <p:nvPr/>
          </p:nvSpPr>
          <p:spPr>
            <a:xfrm>
              <a:off x="5871831" y="6533253"/>
              <a:ext cx="14533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     µm      100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45ACD93A-A22C-CF44-AA79-0ACC5FC1DD5A}"/>
              </a:ext>
            </a:extLst>
          </p:cNvPr>
          <p:cNvSpPr txBox="1"/>
          <p:nvPr/>
        </p:nvSpPr>
        <p:spPr>
          <a:xfrm>
            <a:off x="6419885" y="4773264"/>
            <a:ext cx="5795113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2 Figure</a:t>
            </a:r>
            <a:r>
              <a:rPr lang="en-US" dirty="0"/>
              <a:t>. Immunofluorescence of </a:t>
            </a:r>
            <a:r>
              <a:rPr lang="en-US" i="1" dirty="0"/>
              <a:t>C. perfringens </a:t>
            </a:r>
            <a:r>
              <a:rPr lang="en-US" dirty="0"/>
              <a:t>strain CP4.</a:t>
            </a:r>
          </a:p>
          <a:p>
            <a:r>
              <a:rPr lang="en-US" dirty="0"/>
              <a:t>Cells were incubated with pre-immune sera (Pre-Bleed), </a:t>
            </a:r>
          </a:p>
          <a:p>
            <a:r>
              <a:rPr lang="en-US" dirty="0"/>
              <a:t>secondary antibody only (2</a:t>
            </a:r>
            <a:r>
              <a:rPr lang="en-US" baseline="30000" dirty="0"/>
              <a:t>o</a:t>
            </a:r>
            <a:r>
              <a:rPr lang="en-US" dirty="0"/>
              <a:t> α) or the indicated antisera</a:t>
            </a:r>
          </a:p>
          <a:p>
            <a:r>
              <a:rPr lang="en-US" dirty="0"/>
              <a:t>with or without prior incubation with the indicated </a:t>
            </a:r>
          </a:p>
          <a:p>
            <a:r>
              <a:rPr lang="en-US" dirty="0"/>
              <a:t>recombinant proteins as outlined in the Materials </a:t>
            </a:r>
            <a:r>
              <a:rPr lang="en-US"/>
              <a:t>and </a:t>
            </a:r>
          </a:p>
          <a:p>
            <a:r>
              <a:rPr lang="en-US"/>
              <a:t>Methods section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832811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</Words>
  <Application>Microsoft Macintosh PowerPoint</Application>
  <PresentationFormat>Widescreen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neth Roland</dc:creator>
  <cp:lastModifiedBy>Kenneth Roland</cp:lastModifiedBy>
  <cp:revision>2</cp:revision>
  <dcterms:created xsi:type="dcterms:W3CDTF">2018-05-03T20:11:37Z</dcterms:created>
  <dcterms:modified xsi:type="dcterms:W3CDTF">2018-05-03T20:13:06Z</dcterms:modified>
</cp:coreProperties>
</file>